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>
        <p:scale>
          <a:sx n="100" d="100"/>
          <a:sy n="100" d="100"/>
        </p:scale>
        <p:origin x="460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F5A0F0-2000-C241-BE70-646D1E866BF9}" type="datetimeFigureOut">
              <a:rPr lang="en-US" smtClean="0"/>
              <a:t>10/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655036-EF83-0E49-A50F-CF4F0CC1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727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0827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634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2390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9913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35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5713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7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215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85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75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538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2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60839" y="6870785"/>
            <a:ext cx="609502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>
                <a:latin typeface="Times New Roman" charset="0"/>
                <a:ea typeface="Calibri" charset="0"/>
                <a:cs typeface="Times New Roman" charset="0"/>
              </a:rPr>
              <a:t>Additional file </a:t>
            </a: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5: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Table reporting 2-way ANOVA data </a:t>
            </a: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analysis. 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Data report the % and the p-value of the effect of genoty</a:t>
            </a: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pe, treatment and their interaction on proteins </a:t>
            </a:r>
            <a:r>
              <a:rPr lang="en-GB" dirty="0" err="1" smtClean="0">
                <a:latin typeface="Times New Roman" charset="0"/>
                <a:ea typeface="Calibri" charset="0"/>
                <a:cs typeface="Times New Roman" charset="0"/>
              </a:rPr>
              <a:t>analyzed</a:t>
            </a:r>
            <a:r>
              <a:rPr lang="en-GB" smtClean="0">
                <a:latin typeface="Times New Roman" charset="0"/>
                <a:ea typeface="Calibri" charset="0"/>
                <a:cs typeface="Times New Roman" charset="0"/>
              </a:rPr>
              <a:t> by WB.</a:t>
            </a:r>
            <a:endParaRPr lang="en-GB" dirty="0" smtClean="0">
              <a:latin typeface="Times New Roman" charset="0"/>
              <a:ea typeface="Calibri" charset="0"/>
              <a:cs typeface="Times New Roman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7173268"/>
              </p:ext>
            </p:extLst>
          </p:nvPr>
        </p:nvGraphicFramePr>
        <p:xfrm>
          <a:off x="114299" y="697139"/>
          <a:ext cx="6616699" cy="5690976"/>
        </p:xfrm>
        <a:graphic>
          <a:graphicData uri="http://schemas.openxmlformats.org/drawingml/2006/table">
            <a:tbl>
              <a:tblPr>
                <a:tableStyleId>{46F890A9-2807-4EBB-B81D-B2AA78EC7F39}</a:tableStyleId>
              </a:tblPr>
              <a:tblGrid>
                <a:gridCol w="1008258"/>
                <a:gridCol w="909121"/>
                <a:gridCol w="885480"/>
                <a:gridCol w="976120"/>
                <a:gridCol w="885480"/>
                <a:gridCol w="1052816"/>
                <a:gridCol w="899424"/>
              </a:tblGrid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AT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ENOTYPE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EATM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TERAC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R PI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71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636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.20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699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7.90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24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R DI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5.92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16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05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0.1765</a:t>
                      </a:r>
                      <a:endParaRPr lang="pl-PL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1.02%</a:t>
                      </a:r>
                      <a:endParaRPr lang="hr-H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39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AM Latency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5.71% 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04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.71% 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887</a:t>
                      </a:r>
                      <a:endParaRPr lang="fi-FI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5.32% 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274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AM W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.56% 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756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52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6967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.95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840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AM R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1.71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34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0.91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39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3.45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71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-</a:t>
                      </a:r>
                      <a:r>
                        <a:rPr lang="en-US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TO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2.46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220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0.38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43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7.88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638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-p70S6K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74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3681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3.30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1.14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C3 II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7.38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34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30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678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5.12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tg</a:t>
                      </a:r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12/</a:t>
                      </a:r>
                      <a:r>
                        <a:rPr lang="mr-IN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tg</a:t>
                      </a:r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5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.27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65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3.74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86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2.76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pp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7.20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64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9.58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06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3.56% </a:t>
                      </a:r>
                      <a:endParaRPr lang="sk-SK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0.189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pp a-CTF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3.74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03</a:t>
                      </a:r>
                      <a:endParaRPr lang="hr-H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0.98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21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4.42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88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pp b- CTF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6.95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0.05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0.19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6898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b</a:t>
                      </a:r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B-4 25 </a:t>
                      </a:r>
                      <a:r>
                        <a:rPr lang="mr-IN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D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30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482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4.67% 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92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5.50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64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b 6E10 50 </a:t>
                      </a:r>
                      <a:r>
                        <a:rPr lang="it-IT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D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22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43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5.59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97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6.53% 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11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ACE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39% 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3780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9.83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0.18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7525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-Tau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7.65% 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998</a:t>
                      </a:r>
                      <a:endParaRPr lang="hr-HR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6.64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83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.40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308</a:t>
                      </a:r>
                      <a:endParaRPr lang="hr-HR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SK3b Ser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0.1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9815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6.33% 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300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20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54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SK3b Tyr2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9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7954</a:t>
                      </a:r>
                      <a:endParaRPr lang="fi-FI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7.60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41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0.35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0.7250</a:t>
                      </a:r>
                      <a:endParaRPr lang="pl-PL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yrk1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3.62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389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93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573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1.00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615</a:t>
                      </a:r>
                      <a:endParaRPr lang="pl-PL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CAN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1.52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33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59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74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7.55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71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-PTE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1.50% 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589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2.24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0.0518</a:t>
                      </a:r>
                      <a:endParaRPr lang="pl-PL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48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3670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K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2.93% 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0.1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894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4.22% 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50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-IRS Ser30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82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034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2.94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68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728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-IRS1 Tyr63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89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49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3.89% 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476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51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464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-AMPK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4.38% </a:t>
                      </a:r>
                      <a:endParaRPr lang="sk-S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257</a:t>
                      </a:r>
                      <a:endParaRPr lang="nb-NO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7.26% 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220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8.47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959</a:t>
                      </a:r>
                      <a:endParaRPr lang="hr-H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TX1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03</a:t>
                      </a:r>
                      <a:endParaRPr lang="sk-S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3771</a:t>
                      </a:r>
                      <a:endParaRPr lang="nb-NO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2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858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.43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021</a:t>
                      </a:r>
                      <a:endParaRPr lang="hr-H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SD 9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%</a:t>
                      </a:r>
                      <a:endParaRPr lang="sk-S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996</a:t>
                      </a:r>
                      <a:endParaRPr lang="nb-NO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7.17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77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13%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2711</a:t>
                      </a:r>
                      <a:endParaRPr lang="hr-H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NT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1.05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07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57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166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94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841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N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72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5095</a:t>
                      </a:r>
                      <a:endParaRPr lang="hr-HR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7.01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lt; 0.0001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7.19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437</a:t>
                      </a:r>
                      <a:endParaRPr lang="is-I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8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oly-</a:t>
                      </a:r>
                      <a:r>
                        <a:rPr lang="en-US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b</a:t>
                      </a:r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Lys6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62%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5435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2.71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01</a:t>
                      </a:r>
                      <a:endParaRPr lang="nb-NO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0.84%</a:t>
                      </a:r>
                      <a:endParaRPr lang="mr-I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013</a:t>
                      </a:r>
                      <a:endParaRPr lang="hr-H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283" marR="4283" marT="428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78794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</TotalTime>
  <Words>366</Words>
  <Application>Microsoft Macintosh PowerPoint</Application>
  <PresentationFormat>Widescreen</PresentationFormat>
  <Paragraphs>2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</dc:creator>
  <cp:lastModifiedBy>Fabio Di Domenico</cp:lastModifiedBy>
  <cp:revision>24</cp:revision>
  <dcterms:created xsi:type="dcterms:W3CDTF">2018-05-09T09:13:07Z</dcterms:created>
  <dcterms:modified xsi:type="dcterms:W3CDTF">2018-10-01T07:34:16Z</dcterms:modified>
</cp:coreProperties>
</file>